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64275" cy="76787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BEB5F-271F-4D80-BCFF-E00DC99FA8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56386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2480" y="4438800"/>
            <a:ext cx="56386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BBA02-ED68-4404-920B-30D6C6BCFE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0184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2480" y="443880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01840" y="443880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A13FD-E638-4E21-8057-5B24D79F18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19040" y="179208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25600" y="179208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2480" y="443880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19040" y="443880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25600" y="4438800"/>
            <a:ext cx="1815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CDE9C-0D32-41BF-B89A-1E2018926D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2480" y="1792080"/>
            <a:ext cx="5638680" cy="5067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26"/>
              </a:spcBef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D6B68-3F19-4739-AAAC-F05B340980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56386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49A73-7BD0-4A22-BAB5-741DB94387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27514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01840" y="1792080"/>
            <a:ext cx="27514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4EBFB-D57A-46D6-A8B1-A198D8E351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0D4C0-E797-42D3-BA18-C4C65566F7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2480" y="307440"/>
            <a:ext cx="5638680" cy="59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26"/>
              </a:spcBef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BB784-686E-4826-A5FF-C34A667764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01840" y="1792080"/>
            <a:ext cx="27514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2480" y="443880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40F08-B3DA-42B5-9B2D-FF3B039432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27514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0184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01840" y="443880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E610E-86B8-4B08-AD87-7CBC8BA164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248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01840" y="1792080"/>
            <a:ext cx="27514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2480" y="4438800"/>
            <a:ext cx="5638680" cy="2416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indent="0" algn="r" rtl="1">
              <a:spcBef>
                <a:spcPts val="726"/>
              </a:spcBef>
              <a:buNone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F7AD7-2434-4A8D-8A1E-7C1D9CE05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2480" y="307440"/>
            <a:ext cx="5638680" cy="12798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 algn="ctr" rtl="1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2480" y="1792080"/>
            <a:ext cx="5638680" cy="506700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t">
            <a:normAutofit/>
          </a:bodyPr>
          <a:p>
            <a:pPr marL="311040" indent="-311040" algn="r" rtl="1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1" marL="674640" indent="-258840" algn="r" rtl="1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2" marL="1038240" indent="-206280" algn="r" rtl="1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3" marL="1454040" indent="-206280" algn="r" rtl="1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4" marL="1868400" indent="-206280" algn="r" rtl="1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5" marL="1868400" indent="-206280" algn="r" rtl="1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6" marL="1868400" indent="-206280" algn="r" rtl="1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489200" y="7118280"/>
            <a:ext cx="1461960" cy="409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  <a:defRPr b="0" lang="he-IL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he-IL" sz="1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39840" y="7118280"/>
            <a:ext cx="1984320" cy="409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p>
            <a:pPr indent="0"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12480" y="7118280"/>
            <a:ext cx="1461960" cy="409680"/>
          </a:xfrm>
          <a:prstGeom prst="rect">
            <a:avLst/>
          </a:prstGeom>
          <a:noFill/>
          <a:ln w="0">
            <a:noFill/>
          </a:ln>
        </p:spPr>
        <p:txBody>
          <a:bodyPr lIns="83160" rIns="83160" tIns="41400" bIns="414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  <a:defRPr b="0" lang="he-IL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fld id="{D45DE01D-9957-4E5B-AF8F-9C8A18A2C5EB}" type="slidenum">
              <a:rPr b="0" lang="he-IL" sz="1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4"/>
          <p:cNvSpPr/>
          <p:nvPr/>
        </p:nvSpPr>
        <p:spPr>
          <a:xfrm>
            <a:off x="260280" y="714240"/>
            <a:ext cx="3087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verexpression cassette (TMS1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801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44"/>
          <p:cNvGrpSpPr/>
          <p:nvPr/>
        </p:nvGrpSpPr>
        <p:grpSpPr>
          <a:xfrm>
            <a:off x="33480" y="3006720"/>
            <a:ext cx="500040" cy="246240"/>
            <a:chOff x="33480" y="3006720"/>
            <a:chExt cx="500040" cy="246240"/>
          </a:xfrm>
        </p:grpSpPr>
        <p:sp>
          <p:nvSpPr>
            <p:cNvPr id="43" name="Straight Connector 140"/>
            <p:cNvSpPr/>
            <p:nvPr/>
          </p:nvSpPr>
          <p:spPr>
            <a:xfrm>
              <a:off x="112680" y="3011400"/>
              <a:ext cx="360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143"/>
            <p:cNvSpPr/>
            <p:nvPr/>
          </p:nvSpPr>
          <p:spPr>
            <a:xfrm>
              <a:off x="33480" y="3006720"/>
              <a:ext cx="50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30160"/>
                  <a:tab algn="l" pos="1660680"/>
                  <a:tab algn="l" pos="2490840"/>
                  <a:tab algn="l" pos="3321000"/>
                  <a:tab algn="l" pos="4151160"/>
                  <a:tab algn="l" pos="4981680"/>
                  <a:tab algn="l" pos="5811840"/>
                  <a:tab algn="l" pos="6642000"/>
                  <a:tab algn="l" pos="7472520"/>
                  <a:tab algn="l" pos="8302680"/>
                  <a:tab algn="l" pos="9132840"/>
                  <a:tab algn="l" pos="9963000"/>
                  <a:tab algn="l" pos="10793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TextBox 159"/>
          <p:cNvSpPr/>
          <p:nvPr/>
        </p:nvSpPr>
        <p:spPr>
          <a:xfrm>
            <a:off x="254520" y="6746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60"/>
          <p:cNvSpPr/>
          <p:nvPr/>
        </p:nvSpPr>
        <p:spPr>
          <a:xfrm>
            <a:off x="243720" y="356544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26"/>
          <p:cNvSpPr/>
          <p:nvPr/>
        </p:nvSpPr>
        <p:spPr>
          <a:xfrm>
            <a:off x="1190520" y="1697040"/>
            <a:ext cx="61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c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32"/>
          <p:cNvSpPr/>
          <p:nvPr/>
        </p:nvSpPr>
        <p:spPr>
          <a:xfrm>
            <a:off x="28440" y="1535040"/>
            <a:ext cx="389592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ight Arrow 133"/>
          <p:cNvSpPr/>
          <p:nvPr/>
        </p:nvSpPr>
        <p:spPr>
          <a:xfrm>
            <a:off x="453960" y="1395360"/>
            <a:ext cx="1044720" cy="287280"/>
          </a:xfrm>
          <a:prstGeom prst="rightArrow">
            <a:avLst>
              <a:gd name="adj1" fmla="val 50000"/>
              <a:gd name="adj2" fmla="val 50020"/>
            </a:avLst>
          </a:prstGeom>
          <a:solidFill>
            <a:srgbClr val="dce6f2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ight Arrow 135"/>
          <p:cNvSpPr/>
          <p:nvPr/>
        </p:nvSpPr>
        <p:spPr>
          <a:xfrm>
            <a:off x="1500120" y="1395360"/>
            <a:ext cx="612720" cy="287280"/>
          </a:xfrm>
          <a:prstGeom prst="rightArrow">
            <a:avLst>
              <a:gd name="adj1" fmla="val 50000"/>
              <a:gd name="adj2" fmla="val 50003"/>
            </a:avLst>
          </a:prstGeom>
          <a:solidFill>
            <a:srgbClr val="95b3d7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ight Arrow 139"/>
          <p:cNvSpPr/>
          <p:nvPr/>
        </p:nvSpPr>
        <p:spPr>
          <a:xfrm>
            <a:off x="2117880" y="1400040"/>
            <a:ext cx="1309680" cy="287640"/>
          </a:xfrm>
          <a:prstGeom prst="rightArrow">
            <a:avLst>
              <a:gd name="adj1" fmla="val 50000"/>
              <a:gd name="adj2" fmla="val 49938"/>
            </a:avLst>
          </a:prstGeom>
          <a:solidFill>
            <a:srgbClr val="10253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53"/>
          <p:cNvSpPr/>
          <p:nvPr/>
        </p:nvSpPr>
        <p:spPr>
          <a:xfrm>
            <a:off x="1498680" y="1547640"/>
            <a:ext cx="0" cy="208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" name="Straight Arrow Connector 154"/>
          <p:cNvCxnSpPr/>
          <p:nvPr/>
        </p:nvCxnSpPr>
        <p:spPr>
          <a:xfrm flipH="1">
            <a:off x="3369600" y="1921320"/>
            <a:ext cx="73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54" name="Straight Arrow Connector 163"/>
          <p:cNvCxnSpPr/>
          <p:nvPr/>
        </p:nvCxnSpPr>
        <p:spPr>
          <a:xfrm>
            <a:off x="1494360" y="192420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55" name="Left Brace 167"/>
          <p:cNvSpPr/>
          <p:nvPr/>
        </p:nvSpPr>
        <p:spPr>
          <a:xfrm rot="16200000">
            <a:off x="2032560" y="1905480"/>
            <a:ext cx="71640" cy="2212920"/>
          </a:xfrm>
          <a:custGeom>
            <a:avLst/>
            <a:gdLst>
              <a:gd name="textAreaLeft" fmla="*/ 45720 w 71640"/>
              <a:gd name="textAreaRight" fmla="*/ 72000 w 71640"/>
              <a:gd name="textAreaTop" fmla="*/ 1800 h 2212920"/>
              <a:gd name="textAreaBottom" fmla="*/ 2211120 h 2212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9"/>
                  <a:pt x="10800" y="58"/>
                </a:cubicBezTo>
                <a:lnTo>
                  <a:pt x="10800" y="10742"/>
                </a:lnTo>
                <a:cubicBezTo>
                  <a:pt x="10800" y="10771"/>
                  <a:pt x="5400" y="10800"/>
                  <a:pt x="0" y="10800"/>
                </a:cubicBezTo>
                <a:cubicBezTo>
                  <a:pt x="5400" y="10800"/>
                  <a:pt x="10800" y="10829"/>
                  <a:pt x="10800" y="10858"/>
                </a:cubicBezTo>
                <a:lnTo>
                  <a:pt x="10800" y="21542"/>
                </a:lnTo>
                <a:cubicBezTo>
                  <a:pt x="10800" y="2157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21"/>
          <p:cNvSpPr/>
          <p:nvPr/>
        </p:nvSpPr>
        <p:spPr>
          <a:xfrm>
            <a:off x="1711440" y="301608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147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26"/>
          <p:cNvSpPr/>
          <p:nvPr/>
        </p:nvSpPr>
        <p:spPr>
          <a:xfrm>
            <a:off x="3276720" y="1319040"/>
            <a:ext cx="79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GEM-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26"/>
          <p:cNvSpPr/>
          <p:nvPr/>
        </p:nvSpPr>
        <p:spPr>
          <a:xfrm>
            <a:off x="3108240" y="169704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26"/>
          <p:cNvSpPr/>
          <p:nvPr/>
        </p:nvSpPr>
        <p:spPr>
          <a:xfrm>
            <a:off x="2222640" y="992160"/>
            <a:ext cx="968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DS &amp; Termina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6"/>
          <p:cNvSpPr/>
          <p:nvPr/>
        </p:nvSpPr>
        <p:spPr>
          <a:xfrm>
            <a:off x="1306440" y="1033560"/>
            <a:ext cx="963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mo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6"/>
          <p:cNvSpPr/>
          <p:nvPr/>
        </p:nvSpPr>
        <p:spPr>
          <a:xfrm>
            <a:off x="485640" y="110808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bx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92"/>
          <p:cNvSpPr/>
          <p:nvPr/>
        </p:nvSpPr>
        <p:spPr>
          <a:xfrm>
            <a:off x="3429000" y="1546200"/>
            <a:ext cx="0" cy="208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Straight Arrow Connector 194"/>
          <p:cNvCxnSpPr/>
          <p:nvPr/>
        </p:nvCxnSpPr>
        <p:spPr>
          <a:xfrm flipH="1">
            <a:off x="2047680" y="1921320"/>
            <a:ext cx="7344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64" name="Straight Arrow Connector 196"/>
          <p:cNvCxnSpPr/>
          <p:nvPr/>
        </p:nvCxnSpPr>
        <p:spPr>
          <a:xfrm>
            <a:off x="2111760" y="192096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65" name="TextBox 221"/>
          <p:cNvSpPr/>
          <p:nvPr/>
        </p:nvSpPr>
        <p:spPr>
          <a:xfrm rot="5400000">
            <a:off x="1023840" y="23065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cII-btub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21"/>
          <p:cNvSpPr/>
          <p:nvPr/>
        </p:nvSpPr>
        <p:spPr>
          <a:xfrm rot="5400000">
            <a:off x="1565280" y="2305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F-btubP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21"/>
          <p:cNvSpPr/>
          <p:nvPr/>
        </p:nvSpPr>
        <p:spPr>
          <a:xfrm rot="5400000">
            <a:off x="1682280" y="23018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tubPR-cre1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21"/>
          <p:cNvSpPr/>
          <p:nvPr/>
        </p:nvSpPr>
        <p:spPr>
          <a:xfrm rot="5400000">
            <a:off x="2921760" y="230004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R-Sp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21"/>
          <p:cNvSpPr/>
          <p:nvPr/>
        </p:nvSpPr>
        <p:spPr>
          <a:xfrm>
            <a:off x="1447920" y="2760840"/>
            <a:ext cx="71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704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21"/>
          <p:cNvSpPr/>
          <p:nvPr/>
        </p:nvSpPr>
        <p:spPr>
          <a:xfrm>
            <a:off x="2413080" y="275904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641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1" name="Straight Arrow Connector 212"/>
          <p:cNvCxnSpPr/>
          <p:nvPr/>
        </p:nvCxnSpPr>
        <p:spPr>
          <a:xfrm flipH="1">
            <a:off x="3101760" y="1920960"/>
            <a:ext cx="7344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72" name="Straight Arrow Connector 214"/>
          <p:cNvCxnSpPr/>
          <p:nvPr/>
        </p:nvCxnSpPr>
        <p:spPr>
          <a:xfrm>
            <a:off x="972000" y="1923120"/>
            <a:ext cx="7380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73" name="TextBox 221"/>
          <p:cNvSpPr/>
          <p:nvPr/>
        </p:nvSpPr>
        <p:spPr>
          <a:xfrm rot="5400000">
            <a:off x="502920" y="2305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MS17D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21"/>
          <p:cNvSpPr/>
          <p:nvPr/>
        </p:nvSpPr>
        <p:spPr>
          <a:xfrm rot="5400000">
            <a:off x="2630520" y="23032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MS17D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eft Brace 90"/>
          <p:cNvSpPr/>
          <p:nvPr/>
        </p:nvSpPr>
        <p:spPr>
          <a:xfrm rot="16200000">
            <a:off x="2732760" y="2097360"/>
            <a:ext cx="71640" cy="1311480"/>
          </a:xfrm>
          <a:custGeom>
            <a:avLst/>
            <a:gdLst>
              <a:gd name="textAreaLeft" fmla="*/ 45720 w 71640"/>
              <a:gd name="textAreaRight" fmla="*/ 72000 w 71640"/>
              <a:gd name="textAreaTop" fmla="*/ 1800 h 1311480"/>
              <a:gd name="textAreaBottom" fmla="*/ 1309680 h 13114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49"/>
                  <a:pt x="10800" y="98"/>
                </a:cubicBezTo>
                <a:lnTo>
                  <a:pt x="10800" y="10702"/>
                </a:lnTo>
                <a:cubicBezTo>
                  <a:pt x="10800" y="10751"/>
                  <a:pt x="5400" y="10800"/>
                  <a:pt x="0" y="10800"/>
                </a:cubicBezTo>
                <a:cubicBezTo>
                  <a:pt x="5400" y="10800"/>
                  <a:pt x="10800" y="10849"/>
                  <a:pt x="10800" y="10898"/>
                </a:cubicBezTo>
                <a:lnTo>
                  <a:pt x="10800" y="21502"/>
                </a:lnTo>
                <a:cubicBezTo>
                  <a:pt x="10800" y="2155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eft Brace 97"/>
          <p:cNvSpPr/>
          <p:nvPr/>
        </p:nvSpPr>
        <p:spPr>
          <a:xfrm rot="16200000">
            <a:off x="1762560" y="2446560"/>
            <a:ext cx="71640" cy="612720"/>
          </a:xfrm>
          <a:custGeom>
            <a:avLst/>
            <a:gdLst>
              <a:gd name="textAreaLeft" fmla="*/ 45720 w 71640"/>
              <a:gd name="textAreaRight" fmla="*/ 72000 w 71640"/>
              <a:gd name="textAreaTop" fmla="*/ 1800 h 612720"/>
              <a:gd name="textAreaBottom" fmla="*/ 610920 h 612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5"/>
                  <a:pt x="10800" y="210"/>
                </a:cubicBezTo>
                <a:lnTo>
                  <a:pt x="10800" y="10590"/>
                </a:lnTo>
                <a:cubicBezTo>
                  <a:pt x="10800" y="10695"/>
                  <a:pt x="5400" y="10800"/>
                  <a:pt x="0" y="10800"/>
                </a:cubicBezTo>
                <a:cubicBezTo>
                  <a:pt x="5400" y="10800"/>
                  <a:pt x="10800" y="10905"/>
                  <a:pt x="10800" y="11010"/>
                </a:cubicBezTo>
                <a:lnTo>
                  <a:pt x="10800" y="21390"/>
                </a:lnTo>
                <a:cubicBezTo>
                  <a:pt x="10800" y="21495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44"/>
          <p:cNvSpPr/>
          <p:nvPr/>
        </p:nvSpPr>
        <p:spPr>
          <a:xfrm>
            <a:off x="249120" y="3608280"/>
            <a:ext cx="3087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nockout cassette (TMS1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166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Group 144"/>
          <p:cNvGrpSpPr/>
          <p:nvPr/>
        </p:nvGrpSpPr>
        <p:grpSpPr>
          <a:xfrm>
            <a:off x="39600" y="6937200"/>
            <a:ext cx="500040" cy="246240"/>
            <a:chOff x="39600" y="6937200"/>
            <a:chExt cx="500040" cy="246240"/>
          </a:xfrm>
        </p:grpSpPr>
        <p:sp>
          <p:nvSpPr>
            <p:cNvPr id="79" name="Straight Connector 78"/>
            <p:cNvSpPr/>
            <p:nvPr/>
          </p:nvSpPr>
          <p:spPr>
            <a:xfrm>
              <a:off x="118800" y="6941880"/>
              <a:ext cx="360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43"/>
            <p:cNvSpPr/>
            <p:nvPr/>
          </p:nvSpPr>
          <p:spPr>
            <a:xfrm>
              <a:off x="39600" y="6937200"/>
              <a:ext cx="50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30160"/>
                  <a:tab algn="l" pos="1660680"/>
                  <a:tab algn="l" pos="2490840"/>
                  <a:tab algn="l" pos="3321000"/>
                  <a:tab algn="l" pos="4151160"/>
                  <a:tab algn="l" pos="4981680"/>
                  <a:tab algn="l" pos="5811840"/>
                  <a:tab algn="l" pos="6642000"/>
                  <a:tab algn="l" pos="7472520"/>
                  <a:tab algn="l" pos="8302680"/>
                  <a:tab algn="l" pos="9132840"/>
                  <a:tab algn="l" pos="9963000"/>
                  <a:tab algn="l" pos="10793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k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Straight Connector 83"/>
          <p:cNvSpPr/>
          <p:nvPr/>
        </p:nvSpPr>
        <p:spPr>
          <a:xfrm>
            <a:off x="108000" y="4272120"/>
            <a:ext cx="3552840" cy="144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2" name="Straight Arrow Connector 89"/>
          <p:cNvCxnSpPr/>
          <p:nvPr/>
        </p:nvCxnSpPr>
        <p:spPr>
          <a:xfrm>
            <a:off x="1219680" y="4502520"/>
            <a:ext cx="73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83" name="Left Brace 91"/>
          <p:cNvSpPr/>
          <p:nvPr/>
        </p:nvSpPr>
        <p:spPr>
          <a:xfrm rot="16200000">
            <a:off x="1339200" y="6296760"/>
            <a:ext cx="71280" cy="1292400"/>
          </a:xfrm>
          <a:custGeom>
            <a:avLst/>
            <a:gdLst>
              <a:gd name="textAreaLeft" fmla="*/ 45720 w 71280"/>
              <a:gd name="textAreaRight" fmla="*/ 71640 w 71280"/>
              <a:gd name="textAreaTop" fmla="*/ 1800 h 1292400"/>
              <a:gd name="textAreaBottom" fmla="*/ 1290600 h 12924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50"/>
                  <a:pt x="10800" y="100"/>
                </a:cubicBezTo>
                <a:lnTo>
                  <a:pt x="10800" y="10700"/>
                </a:lnTo>
                <a:cubicBezTo>
                  <a:pt x="10800" y="10750"/>
                  <a:pt x="5400" y="10800"/>
                  <a:pt x="0" y="10800"/>
                </a:cubicBezTo>
                <a:cubicBezTo>
                  <a:pt x="5400" y="10800"/>
                  <a:pt x="10800" y="10850"/>
                  <a:pt x="10800" y="10900"/>
                </a:cubicBezTo>
                <a:lnTo>
                  <a:pt x="10800" y="21500"/>
                </a:lnTo>
                <a:cubicBezTo>
                  <a:pt x="10800" y="21550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221"/>
          <p:cNvSpPr/>
          <p:nvPr/>
        </p:nvSpPr>
        <p:spPr>
          <a:xfrm>
            <a:off x="1017720" y="694548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89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26"/>
          <p:cNvSpPr/>
          <p:nvPr/>
        </p:nvSpPr>
        <p:spPr>
          <a:xfrm>
            <a:off x="3060720" y="4056120"/>
            <a:ext cx="79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GEM-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226"/>
          <p:cNvSpPr/>
          <p:nvPr/>
        </p:nvSpPr>
        <p:spPr>
          <a:xfrm>
            <a:off x="387360" y="393048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3’ fla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7" name="Straight Arrow Connector 100"/>
          <p:cNvCxnSpPr/>
          <p:nvPr/>
        </p:nvCxnSpPr>
        <p:spPr>
          <a:xfrm flipH="1">
            <a:off x="1149120" y="4505400"/>
            <a:ext cx="7344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88" name="Straight Arrow Connector 101"/>
          <p:cNvCxnSpPr/>
          <p:nvPr/>
        </p:nvCxnSpPr>
        <p:spPr>
          <a:xfrm>
            <a:off x="2381760" y="4505760"/>
            <a:ext cx="73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89" name="TextBox 221"/>
          <p:cNvSpPr/>
          <p:nvPr/>
        </p:nvSpPr>
        <p:spPr>
          <a:xfrm rot="5400000">
            <a:off x="798480" y="487836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PR-hyg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21"/>
          <p:cNvSpPr/>
          <p:nvPr/>
        </p:nvSpPr>
        <p:spPr>
          <a:xfrm rot="5400000">
            <a:off x="1820520" y="487656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TF-hyg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21"/>
          <p:cNvSpPr/>
          <p:nvPr/>
        </p:nvSpPr>
        <p:spPr>
          <a:xfrm rot="5400000">
            <a:off x="1964880" y="48736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gR-cre1T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21"/>
          <p:cNvSpPr/>
          <p:nvPr/>
        </p:nvSpPr>
        <p:spPr>
          <a:xfrm>
            <a:off x="507960" y="5367240"/>
            <a:ext cx="71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23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21"/>
          <p:cNvSpPr/>
          <p:nvPr/>
        </p:nvSpPr>
        <p:spPr>
          <a:xfrm>
            <a:off x="1450800" y="5365800"/>
            <a:ext cx="71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04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4" name="Straight Arrow Connector 108"/>
          <p:cNvCxnSpPr/>
          <p:nvPr/>
        </p:nvCxnSpPr>
        <p:spPr>
          <a:xfrm flipH="1">
            <a:off x="3026520" y="4502520"/>
            <a:ext cx="73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95" name="Straight Arrow Connector 109"/>
          <p:cNvCxnSpPr/>
          <p:nvPr/>
        </p:nvCxnSpPr>
        <p:spPr>
          <a:xfrm>
            <a:off x="511560" y="450540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96" name="TextBox 221"/>
          <p:cNvSpPr/>
          <p:nvPr/>
        </p:nvSpPr>
        <p:spPr>
          <a:xfrm rot="5400000">
            <a:off x="42480" y="487656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21"/>
          <p:cNvSpPr/>
          <p:nvPr/>
        </p:nvSpPr>
        <p:spPr>
          <a:xfrm rot="5400000">
            <a:off x="2565360" y="48751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226"/>
          <p:cNvSpPr/>
          <p:nvPr/>
        </p:nvSpPr>
        <p:spPr>
          <a:xfrm>
            <a:off x="2295360" y="393048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5’ fla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226"/>
          <p:cNvSpPr/>
          <p:nvPr/>
        </p:nvSpPr>
        <p:spPr>
          <a:xfrm>
            <a:off x="1314360" y="392760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g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18"/>
          <p:cNvSpPr/>
          <p:nvPr/>
        </p:nvSpPr>
        <p:spPr>
          <a:xfrm>
            <a:off x="1228680" y="4222800"/>
            <a:ext cx="1152720" cy="1857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20"/>
          <p:cNvSpPr/>
          <p:nvPr/>
        </p:nvSpPr>
        <p:spPr>
          <a:xfrm>
            <a:off x="506520" y="4221000"/>
            <a:ext cx="720720" cy="187560"/>
          </a:xfrm>
          <a:prstGeom prst="rect">
            <a:avLst/>
          </a:prstGeom>
          <a:solidFill>
            <a:srgbClr val="95b3d7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121"/>
          <p:cNvSpPr/>
          <p:nvPr/>
        </p:nvSpPr>
        <p:spPr>
          <a:xfrm>
            <a:off x="2381400" y="4221000"/>
            <a:ext cx="720720" cy="187560"/>
          </a:xfrm>
          <a:prstGeom prst="rect">
            <a:avLst/>
          </a:prstGeom>
          <a:solidFill>
            <a:srgbClr val="95b3d7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Straight Arrow Connector 136"/>
          <p:cNvCxnSpPr/>
          <p:nvPr/>
        </p:nvCxnSpPr>
        <p:spPr>
          <a:xfrm flipH="1">
            <a:off x="2309040" y="4505760"/>
            <a:ext cx="73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104" name="TextBox 221"/>
          <p:cNvSpPr/>
          <p:nvPr/>
        </p:nvSpPr>
        <p:spPr>
          <a:xfrm rot="5400000">
            <a:off x="661680" y="487980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gF-cre1P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5" name="Straight Arrow Connector 138"/>
          <p:cNvCxnSpPr/>
          <p:nvPr/>
        </p:nvCxnSpPr>
        <p:spPr>
          <a:xfrm flipH="1">
            <a:off x="1951920" y="641844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106" name="TextBox 221"/>
          <p:cNvSpPr/>
          <p:nvPr/>
        </p:nvSpPr>
        <p:spPr>
          <a:xfrm rot="5400000">
            <a:off x="1495440" y="67388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D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Group 13"/>
          <p:cNvGrpSpPr/>
          <p:nvPr/>
        </p:nvGrpSpPr>
        <p:grpSpPr>
          <a:xfrm>
            <a:off x="504720" y="5326200"/>
            <a:ext cx="2603520" cy="72720"/>
            <a:chOff x="504720" y="5326200"/>
            <a:chExt cx="2603520" cy="72720"/>
          </a:xfrm>
        </p:grpSpPr>
        <p:sp>
          <p:nvSpPr>
            <p:cNvPr id="108" name="Left Brace 112"/>
            <p:cNvSpPr/>
            <p:nvPr/>
          </p:nvSpPr>
          <p:spPr>
            <a:xfrm rot="16200000">
              <a:off x="1771200" y="4787640"/>
              <a:ext cx="71280" cy="1150920"/>
            </a:xfrm>
            <a:custGeom>
              <a:avLst/>
              <a:gdLst>
                <a:gd name="textAreaLeft" fmla="*/ 45720 w 71280"/>
                <a:gd name="textAreaRight" fmla="*/ 71640 w 71280"/>
                <a:gd name="textAreaTop" fmla="*/ 1800 h 1150920"/>
                <a:gd name="textAreaBottom" fmla="*/ 1149120 h 1150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56"/>
                    <a:pt x="10800" y="111"/>
                  </a:cubicBezTo>
                  <a:lnTo>
                    <a:pt x="10800" y="10689"/>
                  </a:lnTo>
                  <a:cubicBezTo>
                    <a:pt x="10800" y="10745"/>
                    <a:pt x="5400" y="10800"/>
                    <a:pt x="0" y="10800"/>
                  </a:cubicBezTo>
                  <a:cubicBezTo>
                    <a:pt x="5400" y="10800"/>
                    <a:pt x="10800" y="10856"/>
                    <a:pt x="10800" y="10911"/>
                  </a:cubicBezTo>
                  <a:lnTo>
                    <a:pt x="10800" y="21489"/>
                  </a:lnTo>
                  <a:cubicBezTo>
                    <a:pt x="10800" y="21545"/>
                    <a:pt x="16200" y="21600"/>
                    <a:pt x="2160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tabLst>
                  <a:tab algn="l" pos="0"/>
                  <a:tab algn="l" pos="830160"/>
                  <a:tab algn="l" pos="1660680"/>
                  <a:tab algn="l" pos="2490840"/>
                  <a:tab algn="l" pos="3321000"/>
                  <a:tab algn="l" pos="4151160"/>
                  <a:tab algn="l" pos="4981680"/>
                  <a:tab algn="l" pos="5811840"/>
                  <a:tab algn="l" pos="6642000"/>
                  <a:tab algn="l" pos="7472520"/>
                  <a:tab algn="l" pos="8302680"/>
                  <a:tab algn="l" pos="9132840"/>
                  <a:tab algn="l" pos="9963000"/>
                  <a:tab algn="l" pos="1079352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eft Brace 113"/>
            <p:cNvSpPr/>
            <p:nvPr/>
          </p:nvSpPr>
          <p:spPr>
            <a:xfrm rot="16200000">
              <a:off x="828360" y="5003640"/>
              <a:ext cx="71280" cy="718920"/>
            </a:xfrm>
            <a:custGeom>
              <a:avLst/>
              <a:gdLst>
                <a:gd name="textAreaLeft" fmla="*/ 45720 w 71280"/>
                <a:gd name="textAreaRight" fmla="*/ 71640 w 71280"/>
                <a:gd name="textAreaTop" fmla="*/ 1800 h 718920"/>
                <a:gd name="textAreaBottom" fmla="*/ 717120 h 718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89"/>
                    <a:pt x="10800" y="177"/>
                  </a:cubicBezTo>
                  <a:lnTo>
                    <a:pt x="10800" y="10623"/>
                  </a:lnTo>
                  <a:cubicBezTo>
                    <a:pt x="10800" y="10712"/>
                    <a:pt x="5400" y="10800"/>
                    <a:pt x="0" y="10800"/>
                  </a:cubicBezTo>
                  <a:cubicBezTo>
                    <a:pt x="5400" y="10800"/>
                    <a:pt x="10800" y="10889"/>
                    <a:pt x="10800" y="10977"/>
                  </a:cubicBezTo>
                  <a:lnTo>
                    <a:pt x="10800" y="21423"/>
                  </a:lnTo>
                  <a:cubicBezTo>
                    <a:pt x="10800" y="21512"/>
                    <a:pt x="16200" y="21600"/>
                    <a:pt x="2160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tabLst>
                  <a:tab algn="l" pos="0"/>
                  <a:tab algn="l" pos="830160"/>
                  <a:tab algn="l" pos="1660680"/>
                  <a:tab algn="l" pos="2490840"/>
                  <a:tab algn="l" pos="3321000"/>
                  <a:tab algn="l" pos="4151160"/>
                  <a:tab algn="l" pos="4981680"/>
                  <a:tab algn="l" pos="5811840"/>
                  <a:tab algn="l" pos="6642000"/>
                  <a:tab algn="l" pos="7472520"/>
                  <a:tab algn="l" pos="8302680"/>
                  <a:tab algn="l" pos="9132840"/>
                  <a:tab algn="l" pos="9963000"/>
                  <a:tab algn="l" pos="1079352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eft Brace 142"/>
            <p:cNvSpPr/>
            <p:nvPr/>
          </p:nvSpPr>
          <p:spPr>
            <a:xfrm rot="16200000">
              <a:off x="2712960" y="5002200"/>
              <a:ext cx="71280" cy="718920"/>
            </a:xfrm>
            <a:custGeom>
              <a:avLst/>
              <a:gdLst>
                <a:gd name="textAreaLeft" fmla="*/ 45720 w 71280"/>
                <a:gd name="textAreaRight" fmla="*/ 71640 w 71280"/>
                <a:gd name="textAreaTop" fmla="*/ 1800 h 718920"/>
                <a:gd name="textAreaBottom" fmla="*/ 717120 h 718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89"/>
                    <a:pt x="10800" y="177"/>
                  </a:cubicBezTo>
                  <a:lnTo>
                    <a:pt x="10800" y="10623"/>
                  </a:lnTo>
                  <a:cubicBezTo>
                    <a:pt x="10800" y="10712"/>
                    <a:pt x="5400" y="10800"/>
                    <a:pt x="0" y="10800"/>
                  </a:cubicBezTo>
                  <a:cubicBezTo>
                    <a:pt x="5400" y="10800"/>
                    <a:pt x="10800" y="10889"/>
                    <a:pt x="10800" y="10977"/>
                  </a:cubicBezTo>
                  <a:lnTo>
                    <a:pt x="10800" y="21423"/>
                  </a:lnTo>
                  <a:cubicBezTo>
                    <a:pt x="10800" y="21512"/>
                    <a:pt x="16200" y="21600"/>
                    <a:pt x="2160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tabLst>
                  <a:tab algn="l" pos="0"/>
                  <a:tab algn="l" pos="830160"/>
                  <a:tab algn="l" pos="1660680"/>
                  <a:tab algn="l" pos="2490840"/>
                  <a:tab algn="l" pos="3321000"/>
                  <a:tab algn="l" pos="4151160"/>
                  <a:tab algn="l" pos="4981680"/>
                  <a:tab algn="l" pos="5811840"/>
                  <a:tab algn="l" pos="6642000"/>
                  <a:tab algn="l" pos="7472520"/>
                  <a:tab algn="l" pos="8302680"/>
                  <a:tab algn="l" pos="9132840"/>
                  <a:tab algn="l" pos="9963000"/>
                  <a:tab algn="l" pos="1079352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TextBox 221"/>
          <p:cNvSpPr/>
          <p:nvPr/>
        </p:nvSpPr>
        <p:spPr>
          <a:xfrm>
            <a:off x="2389320" y="5365800"/>
            <a:ext cx="71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19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2" name="Straight Arrow Connector 144"/>
          <p:cNvCxnSpPr/>
          <p:nvPr/>
        </p:nvCxnSpPr>
        <p:spPr>
          <a:xfrm>
            <a:off x="722880" y="450540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113" name="Straight Connector 147"/>
          <p:cNvSpPr/>
          <p:nvPr/>
        </p:nvSpPr>
        <p:spPr>
          <a:xfrm>
            <a:off x="117360" y="6234120"/>
            <a:ext cx="3660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44"/>
          <p:cNvSpPr/>
          <p:nvPr/>
        </p:nvSpPr>
        <p:spPr>
          <a:xfrm>
            <a:off x="212760" y="5635800"/>
            <a:ext cx="3087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C9 </a:t>
            </a:r>
            <a:r>
              <a:rPr b="1" i="1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u80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train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omic reg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221"/>
          <p:cNvSpPr/>
          <p:nvPr/>
        </p:nvSpPr>
        <p:spPr>
          <a:xfrm rot="5400000">
            <a:off x="256680" y="485748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D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226"/>
          <p:cNvSpPr/>
          <p:nvPr/>
        </p:nvSpPr>
        <p:spPr>
          <a:xfrm>
            <a:off x="388800" y="584676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3’ fla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226"/>
          <p:cNvSpPr/>
          <p:nvPr/>
        </p:nvSpPr>
        <p:spPr>
          <a:xfrm>
            <a:off x="2297160" y="5846760"/>
            <a:ext cx="9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5’ fla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226"/>
          <p:cNvSpPr/>
          <p:nvPr/>
        </p:nvSpPr>
        <p:spPr>
          <a:xfrm>
            <a:off x="1316160" y="5843520"/>
            <a:ext cx="96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 C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60"/>
          <p:cNvSpPr/>
          <p:nvPr/>
        </p:nvSpPr>
        <p:spPr>
          <a:xfrm>
            <a:off x="1233360" y="6138720"/>
            <a:ext cx="1079640" cy="185760"/>
          </a:xfrm>
          <a:prstGeom prst="rect">
            <a:avLst/>
          </a:prstGeom>
          <a:solidFill>
            <a:srgbClr val="17375e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61"/>
          <p:cNvSpPr/>
          <p:nvPr/>
        </p:nvSpPr>
        <p:spPr>
          <a:xfrm>
            <a:off x="507960" y="6137280"/>
            <a:ext cx="719280" cy="187200"/>
          </a:xfrm>
          <a:prstGeom prst="rect">
            <a:avLst/>
          </a:prstGeom>
          <a:solidFill>
            <a:srgbClr val="95b3d7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62"/>
          <p:cNvSpPr/>
          <p:nvPr/>
        </p:nvSpPr>
        <p:spPr>
          <a:xfrm>
            <a:off x="2320920" y="6137280"/>
            <a:ext cx="719280" cy="187200"/>
          </a:xfrm>
          <a:prstGeom prst="rect">
            <a:avLst/>
          </a:prstGeom>
          <a:solidFill>
            <a:srgbClr val="95b3d7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2" name="Straight Arrow Connector 164"/>
          <p:cNvCxnSpPr/>
          <p:nvPr/>
        </p:nvCxnSpPr>
        <p:spPr>
          <a:xfrm>
            <a:off x="722880" y="6418440"/>
            <a:ext cx="73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123" name="TextBox 221"/>
          <p:cNvSpPr/>
          <p:nvPr/>
        </p:nvSpPr>
        <p:spPr>
          <a:xfrm rot="5400000">
            <a:off x="255240" y="6742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e1D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מלבן 2"/>
          <p:cNvSpPr/>
          <p:nvPr/>
        </p:nvSpPr>
        <p:spPr>
          <a:xfrm>
            <a:off x="3924360" y="600120"/>
            <a:ext cx="2232000" cy="625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: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Genetic manipulation of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cre1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over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expression (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E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) and knockout (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KO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) transformants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trategy for overexpress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. ostreatu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PC9).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β-tubulin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promoter was fused to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coding sequence (CDS) and ligated to the carboxin-resistance-conferring cassette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bx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) to produce the TMS17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assett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. Small arrows indicate the location of primers (Additional file 6: Table S2) used for construction and detection of the construct. PCR verification of the integration was performed using primers TMS17DF and TMS17DR (Additional file 6: Table S2)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trategy for gene replacement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. ostreatu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Δ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ku8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20b). The hygromycin 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resistance-conferring cassette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yg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) was fused to 2 kb of 5’ and 3’ genomic DNA flanking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CDS to produce the TMS18 cassette. Wild-typ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nomic region is illustrated below. PCR Verificat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re1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placement was performed using primers CRE1DF and CRE1DR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Additional file 6: Table S2)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מלבן 3"/>
          <p:cNvSpPr/>
          <p:nvPr/>
        </p:nvSpPr>
        <p:spPr>
          <a:xfrm>
            <a:off x="1267200" y="168120"/>
            <a:ext cx="130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</a:t>
            </a:r>
            <a:r>
              <a:rPr b="1" lang="he-IL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9T18:47:17Z</dcterms:created>
  <dc:creator>Tomer Meir Salame</dc:creator>
  <dc:description/>
  <dc:language>en-US</dc:language>
  <cp:lastModifiedBy>user</cp:lastModifiedBy>
  <dcterms:modified xsi:type="dcterms:W3CDTF">2018-06-18T09:50:57Z</dcterms:modified>
  <cp:revision>138</cp:revision>
  <dc:subject/>
  <dc:title>Slide 1</dc:title>
</cp:coreProperties>
</file>